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gif" ContentType="image/gif"/>
  <Override PartName="/ppt/media/image2.gif" ContentType="image/gi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E84E1-3551-476E-94C8-AF5CB8266D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08934-6292-4469-B547-A43997C9AA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F1279-D88C-420F-8C9D-07D96DB2CC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5BDAC1-E428-4B13-8BD1-0B06BFE397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87A0F5-9B92-4767-963A-0E94770A71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D31F73-77EF-47F7-BD6D-08E7285B86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6CD6DF-0792-4A54-94D8-2D9D17A4A17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00EFA7-EC15-4450-B88F-489BB33805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26CED-4133-42D9-BB7E-9DC8C1BBF09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E2192-97DA-466A-84B3-8403DC8C04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CE95A-AC10-46DD-9331-9367DB4935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599C4-B9FB-41EC-B5F6-7B26A2A7FE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2B57E3-13CC-4AD7-B576-DAD5DD4A637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gif"/><Relationship Id="rId2" Type="http://schemas.openxmlformats.org/officeDocument/2006/relationships/image" Target="../media/image2.gi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Calibri"/>
              </a:rPr>
              <a:t>Cinematographic MRI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/>
          </p:nvPr>
        </p:nvSpPr>
        <p:spPr>
          <a:xfrm>
            <a:off x="456840" y="1534680"/>
            <a:ext cx="4040280" cy="639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400" spc="-1" strike="noStrike">
                <a:solidFill>
                  <a:srgbClr val="000000"/>
                </a:solidFill>
                <a:latin typeface="Calibri"/>
              </a:rPr>
              <a:t>Short axis orientatio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/>
          </p:nvPr>
        </p:nvSpPr>
        <p:spPr>
          <a:xfrm>
            <a:off x="4644720" y="1534680"/>
            <a:ext cx="4041720" cy="639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400" spc="-1" strike="noStrike">
                <a:solidFill>
                  <a:srgbClr val="000000"/>
                </a:solidFill>
                <a:latin typeface="Calibri"/>
              </a:rPr>
              <a:t>Long axis orientation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itle 1"/>
          <p:cNvSpPr/>
          <p:nvPr/>
        </p:nvSpPr>
        <p:spPr>
          <a:xfrm>
            <a:off x="0" y="1125360"/>
            <a:ext cx="9144000" cy="444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800" spc="-1" strike="noStrike">
                <a:solidFill>
                  <a:srgbClr val="000000"/>
                </a:solidFill>
                <a:latin typeface="Calibri"/>
              </a:rPr>
              <a:t>Mild TAC mouse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0" y="6156360"/>
            <a:ext cx="914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2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Representative end diastolic short-axis and long-axis images from a mild TAC mous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10" descr="B:\Publications\articles\2011-04; Phenotyping (in prep)\03_submitted to Plos One\Supplementary material\mTAC\mTAC_Cine_LA.gif"/>
          <p:cNvPicPr/>
          <p:nvPr/>
        </p:nvPicPr>
        <p:blipFill>
          <a:blip r:embed="rId1"/>
          <a:stretch/>
        </p:blipFill>
        <p:spPr>
          <a:xfrm flipH="1">
            <a:off x="4689360" y="2174760"/>
            <a:ext cx="3951360" cy="39513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9" descr="B:\Publications\articles\finished\2012-12; Plos ONE - Phenotyping mTAC sTAC\03_submitted to Plos One (submitted)\Supplementary material\mTAC\mTAC_Cine_SA.gif"/>
          <p:cNvPicPr/>
          <p:nvPr/>
        </p:nvPicPr>
        <p:blipFill>
          <a:blip r:embed="rId2"/>
          <a:stretch/>
        </p:blipFill>
        <p:spPr>
          <a:xfrm flipH="1" rot="16200000">
            <a:off x="501480" y="2174760"/>
            <a:ext cx="3951360" cy="3951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2T11:30:18Z</dcterms:created>
  <dc:creator>B.J van Nierop</dc:creator>
  <dc:description/>
  <dc:language>en-US</dc:language>
  <cp:lastModifiedBy>B.J van Nierop</cp:lastModifiedBy>
  <dcterms:modified xsi:type="dcterms:W3CDTF">2013-01-06T12:23:37Z</dcterms:modified>
  <cp:revision>8</cp:revision>
  <dc:subject/>
  <dc:title>Cinematographic MRI</dc:title>
</cp:coreProperties>
</file>